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7" r:id="rId3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50" d="100"/>
          <a:sy n="150" d="100"/>
        </p:scale>
        <p:origin x="-1812" y="1536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NZ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en-NZ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9AE3E5-B97E-4B11-B1DB-02A8985386C9}" type="datetimeFigureOut">
              <a:rPr lang="en-US" smtClean="0"/>
              <a:t>3/11/2017</a:t>
            </a:fld>
            <a:endParaRPr lang="en-NZ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720F40-74C6-4942-8774-334F3147DD8E}" type="slidenum">
              <a:rPr lang="en-NZ" smtClean="0"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NZ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NZ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9AE3E5-B97E-4B11-B1DB-02A8985386C9}" type="datetimeFigureOut">
              <a:rPr lang="en-US" smtClean="0"/>
              <a:t>3/11/2017</a:t>
            </a:fld>
            <a:endParaRPr lang="en-NZ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720F40-74C6-4942-8774-334F3147DD8E}" type="slidenum">
              <a:rPr lang="en-NZ" smtClean="0"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3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NZ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3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NZ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9AE3E5-B97E-4B11-B1DB-02A8985386C9}" type="datetimeFigureOut">
              <a:rPr lang="en-US" smtClean="0"/>
              <a:t>3/11/2017</a:t>
            </a:fld>
            <a:endParaRPr lang="en-NZ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720F40-74C6-4942-8774-334F3147DD8E}" type="slidenum">
              <a:rPr lang="en-NZ" smtClean="0"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NZ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NZ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9AE3E5-B97E-4B11-B1DB-02A8985386C9}" type="datetimeFigureOut">
              <a:rPr lang="en-US" smtClean="0"/>
              <a:t>3/11/2017</a:t>
            </a:fld>
            <a:endParaRPr lang="en-NZ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720F40-74C6-4942-8774-334F3147DD8E}" type="slidenum">
              <a:rPr lang="en-NZ" smtClean="0"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en-NZ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9AE3E5-B97E-4B11-B1DB-02A8985386C9}" type="datetimeFigureOut">
              <a:rPr lang="en-US" smtClean="0"/>
              <a:t>3/11/2017</a:t>
            </a:fld>
            <a:endParaRPr lang="en-NZ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720F40-74C6-4942-8774-334F3147DD8E}" type="slidenum">
              <a:rPr lang="en-NZ" smtClean="0"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NZ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NZ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NZ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9AE3E5-B97E-4B11-B1DB-02A8985386C9}" type="datetimeFigureOut">
              <a:rPr lang="en-US" smtClean="0"/>
              <a:t>3/11/2017</a:t>
            </a:fld>
            <a:endParaRPr lang="en-NZ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720F40-74C6-4942-8774-334F3147DD8E}" type="slidenum">
              <a:rPr lang="en-NZ" smtClean="0"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en-NZ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NZ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NZ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9AE3E5-B97E-4B11-B1DB-02A8985386C9}" type="datetimeFigureOut">
              <a:rPr lang="en-US" smtClean="0"/>
              <a:t>3/11/2017</a:t>
            </a:fld>
            <a:endParaRPr lang="en-NZ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720F40-74C6-4942-8774-334F3147DD8E}" type="slidenum">
              <a:rPr lang="en-NZ" smtClean="0"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NZ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9AE3E5-B97E-4B11-B1DB-02A8985386C9}" type="datetimeFigureOut">
              <a:rPr lang="en-US" smtClean="0"/>
              <a:t>3/11/2017</a:t>
            </a:fld>
            <a:endParaRPr lang="en-NZ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720F40-74C6-4942-8774-334F3147DD8E}" type="slidenum">
              <a:rPr lang="en-NZ" smtClean="0"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9AE3E5-B97E-4B11-B1DB-02A8985386C9}" type="datetimeFigureOut">
              <a:rPr lang="en-US" smtClean="0"/>
              <a:t>3/11/2017</a:t>
            </a:fld>
            <a:endParaRPr lang="en-NZ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720F40-74C6-4942-8774-334F3147DD8E}" type="slidenum">
              <a:rPr lang="en-NZ" smtClean="0"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en-NZ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8" y="394408"/>
            <a:ext cx="3833812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NZ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9AE3E5-B97E-4B11-B1DB-02A8985386C9}" type="datetimeFigureOut">
              <a:rPr lang="en-US" smtClean="0"/>
              <a:t>3/11/2017</a:t>
            </a:fld>
            <a:endParaRPr lang="en-NZ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720F40-74C6-4942-8774-334F3147DD8E}" type="slidenum">
              <a:rPr lang="en-NZ" smtClean="0"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en-NZ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NZ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9AE3E5-B97E-4B11-B1DB-02A8985386C9}" type="datetimeFigureOut">
              <a:rPr lang="en-US" smtClean="0"/>
              <a:t>3/11/2017</a:t>
            </a:fld>
            <a:endParaRPr lang="en-NZ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720F40-74C6-4942-8774-334F3147DD8E}" type="slidenum">
              <a:rPr lang="en-NZ" smtClean="0"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NZ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NZ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9AE3E5-B97E-4B11-B1DB-02A8985386C9}" type="datetimeFigureOut">
              <a:rPr lang="en-US" smtClean="0"/>
              <a:t>3/11/2017</a:t>
            </a:fld>
            <a:endParaRPr lang="en-NZ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9181397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NZ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720F40-74C6-4942-8774-334F3147DD8E}" type="slidenum">
              <a:rPr lang="en-NZ" smtClean="0"/>
              <a:t>‹#›</a:t>
            </a:fld>
            <a:endParaRPr lang="en-NZ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f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tiff"/><Relationship Id="rId5" Type="http://schemas.openxmlformats.org/officeDocument/2006/relationships/image" Target="../media/image5.tiff"/><Relationship Id="rId4" Type="http://schemas.openxmlformats.org/officeDocument/2006/relationships/image" Target="../media/image4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ZoneTexte 5"/>
          <p:cNvSpPr txBox="1"/>
          <p:nvPr/>
        </p:nvSpPr>
        <p:spPr>
          <a:xfrm>
            <a:off x="908720" y="4504978"/>
            <a:ext cx="5235494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Supplementary Figure S1. </a:t>
            </a:r>
            <a:r>
              <a:rPr lang="en-US" altLang="zh-CN" sz="1200" dirty="0">
                <a:latin typeface="Arial" pitchFamily="34" charset="0"/>
                <a:cs typeface="Arial" pitchFamily="34" charset="0"/>
              </a:rPr>
              <a:t>sh-E2F3 suppressed the E2F3a and E2F3b in C2C12 cells. The C2C12 cells were lentivirally infected by sh-E2F3. Quantitative RT-PCR was performed to </a:t>
            </a:r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analyze </a:t>
            </a:r>
            <a:r>
              <a:rPr lang="en-US" altLang="zh-CN" sz="1200" dirty="0">
                <a:latin typeface="Arial" pitchFamily="34" charset="0"/>
                <a:cs typeface="Arial" pitchFamily="34" charset="0"/>
              </a:rPr>
              <a:t>the expression level of E2F3a and E2F3b. The data were normalized to </a:t>
            </a:r>
            <a:r>
              <a:rPr lang="en-US" altLang="zh-CN" sz="1200" dirty="0">
                <a:latin typeface="Arial" pitchFamily="34" charset="0"/>
                <a:cs typeface="Arial" pitchFamily="34" charset="0"/>
              </a:rPr>
              <a:t> RPL14. </a:t>
            </a:r>
            <a:r>
              <a:rPr lang="en-US" altLang="zh-CN" sz="1200" dirty="0">
                <a:latin typeface="Arial" pitchFamily="34" charset="0"/>
                <a:cs typeface="Arial" pitchFamily="34" charset="0"/>
              </a:rPr>
              <a:t>E2F3a and E2F3b expression in </a:t>
            </a:r>
            <a:r>
              <a:rPr lang="en-US" altLang="zh-CN" sz="1200" dirty="0" err="1">
                <a:latin typeface="Arial" pitchFamily="34" charset="0"/>
                <a:cs typeface="Arial" pitchFamily="34" charset="0"/>
              </a:rPr>
              <a:t>sh</a:t>
            </a:r>
            <a:r>
              <a:rPr lang="en-US" altLang="zh-CN" sz="1200" dirty="0">
                <a:latin typeface="Arial" pitchFamily="34" charset="0"/>
                <a:cs typeface="Arial" pitchFamily="34" charset="0"/>
              </a:rPr>
              <a:t>-Ctrl cells was set to 1.0.</a:t>
            </a:r>
            <a:endParaRPr lang="en-US" sz="1200" dirty="0" smtClean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8" name="图片 17"/>
          <p:cNvPicPr/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844824" y="2216696"/>
            <a:ext cx="3456384" cy="21602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  <p:extLst>
      <p:ext uri="{BB962C8B-B14F-4D97-AF65-F5344CB8AC3E}">
        <p14:creationId xmlns:p14="http://schemas.microsoft.com/office/powerpoint/2010/main" val="149406472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70975" y="458756"/>
            <a:ext cx="1702329" cy="127674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3554" name="Picture 2" descr="C:\Users\hiro\Desktop\9-7图片修改\2014-11-28\CD021.tif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497528" y="452406"/>
            <a:ext cx="1729661" cy="1296000"/>
          </a:xfrm>
          <a:prstGeom prst="rect">
            <a:avLst/>
          </a:prstGeom>
          <a:noFill/>
        </p:spPr>
      </p:pic>
      <p:pic>
        <p:nvPicPr>
          <p:cNvPr id="23555" name="Picture 3" descr="C:\Users\hiro\Desktop\9-7图片修改\2014-11-28\CD103.tif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1497657" y="3156934"/>
            <a:ext cx="1729661" cy="1296000"/>
          </a:xfrm>
          <a:prstGeom prst="rect">
            <a:avLst/>
          </a:prstGeom>
          <a:noFill/>
        </p:spPr>
      </p:pic>
      <p:pic>
        <p:nvPicPr>
          <p:cNvPr id="23556" name="Picture 4" descr="C:\Users\hiro\Desktop\9-7图片修改\2014-11-28\2D331.tif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1497657" y="1799612"/>
            <a:ext cx="1729661" cy="1296000"/>
          </a:xfrm>
          <a:prstGeom prst="rect">
            <a:avLst/>
          </a:prstGeom>
          <a:noFill/>
        </p:spPr>
      </p:pic>
      <p:pic>
        <p:nvPicPr>
          <p:cNvPr id="23557" name="Picture 5" descr="C:\Users\hiro\Desktop\9-7图片修改\2014-11-28\CD5211.tif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3270975" y="1799612"/>
            <a:ext cx="1729661" cy="1296000"/>
          </a:xfrm>
          <a:prstGeom prst="rect">
            <a:avLst/>
          </a:prstGeom>
          <a:noFill/>
        </p:spPr>
      </p:pic>
      <p:sp>
        <p:nvSpPr>
          <p:cNvPr id="9" name="ZoneTexte 3"/>
          <p:cNvSpPr txBox="1"/>
          <p:nvPr/>
        </p:nvSpPr>
        <p:spPr>
          <a:xfrm>
            <a:off x="1441368" y="452406"/>
            <a:ext cx="10301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smtClean="0">
                <a:latin typeface="Arial" pitchFamily="34" charset="0"/>
                <a:cs typeface="Arial" pitchFamily="34" charset="0"/>
              </a:rPr>
              <a:t>CTX-Day 0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ZoneTexte 9"/>
          <p:cNvSpPr txBox="1"/>
          <p:nvPr/>
        </p:nvSpPr>
        <p:spPr>
          <a:xfrm>
            <a:off x="3227318" y="413067"/>
            <a:ext cx="14161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altLang="zh-CN" sz="1200" b="1" dirty="0" smtClean="0">
                <a:latin typeface="Arial" pitchFamily="34" charset="0"/>
                <a:cs typeface="Arial" pitchFamily="34" charset="0"/>
              </a:rPr>
              <a:t>CTX-</a:t>
            </a:r>
            <a:r>
              <a:rPr lang="fr-FR" sz="1200" b="1" dirty="0" smtClean="0">
                <a:latin typeface="Arial" pitchFamily="34" charset="0"/>
                <a:cs typeface="Arial" pitchFamily="34" charset="0"/>
              </a:rPr>
              <a:t>Day 1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ZoneTexte 10"/>
          <p:cNvSpPr txBox="1"/>
          <p:nvPr/>
        </p:nvSpPr>
        <p:spPr>
          <a:xfrm>
            <a:off x="1455118" y="1774732"/>
            <a:ext cx="10301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smtClean="0">
                <a:latin typeface="Arial" pitchFamily="34" charset="0"/>
                <a:cs typeface="Arial" pitchFamily="34" charset="0"/>
              </a:rPr>
              <a:t>CTX-Day 3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ZoneTexte 11"/>
          <p:cNvSpPr txBox="1"/>
          <p:nvPr/>
        </p:nvSpPr>
        <p:spPr>
          <a:xfrm>
            <a:off x="3227318" y="1799990"/>
            <a:ext cx="10301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smtClean="0">
                <a:latin typeface="Arial" pitchFamily="34" charset="0"/>
                <a:cs typeface="Arial" pitchFamily="34" charset="0"/>
              </a:rPr>
              <a:t>CTX-Day 5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ZoneTexte 12"/>
          <p:cNvSpPr txBox="1"/>
          <p:nvPr/>
        </p:nvSpPr>
        <p:spPr>
          <a:xfrm>
            <a:off x="1454000" y="3143070"/>
            <a:ext cx="10301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smtClean="0">
                <a:latin typeface="Arial" pitchFamily="34" charset="0"/>
                <a:cs typeface="Arial" pitchFamily="34" charset="0"/>
              </a:rPr>
              <a:t>CTX-Day 10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ZoneTexte 5"/>
          <p:cNvSpPr txBox="1"/>
          <p:nvPr/>
        </p:nvSpPr>
        <p:spPr>
          <a:xfrm>
            <a:off x="785794" y="4538489"/>
            <a:ext cx="5894883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Supplementary Figure S1. </a:t>
            </a:r>
            <a:r>
              <a:rPr lang="en-NZ" altLang="zh-CN" sz="1200" dirty="0" err="1">
                <a:latin typeface="Arial" pitchFamily="34" charset="0"/>
                <a:cs typeface="Arial" pitchFamily="34" charset="0"/>
              </a:rPr>
              <a:t>Hematoxylin</a:t>
            </a:r>
            <a:r>
              <a:rPr lang="en-NZ" altLang="zh-CN" sz="1200" dirty="0">
                <a:latin typeface="Arial" pitchFamily="34" charset="0"/>
                <a:cs typeface="Arial" pitchFamily="34" charset="0"/>
              </a:rPr>
              <a:t> and eosin</a:t>
            </a:r>
            <a:r>
              <a:rPr lang="en-US" altLang="zh-CN" sz="1200" dirty="0">
                <a:latin typeface="Arial" pitchFamily="34" charset="0"/>
                <a:cs typeface="Arial" pitchFamily="34" charset="0"/>
              </a:rPr>
              <a:t> i</a:t>
            </a:r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mages of tibialis anterior muscle cross sections in C57BL/6 mice on days 0, 1, 3, 5 and 10 post-CTX injury. CTX injection damaged mouse skeletal muscle and leads to an accumulation of </a:t>
            </a:r>
            <a:r>
              <a:rPr lang="en-US" altLang="zh-CN" sz="1200" dirty="0" err="1" smtClean="0">
                <a:latin typeface="Arial" pitchFamily="34" charset="0"/>
                <a:cs typeface="Arial" pitchFamily="34" charset="0"/>
              </a:rPr>
              <a:t>mononucleated</a:t>
            </a:r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 cells. Activated satellites cells  differentiate and form new myofibers to repair damaged muscle. Arrows indicate the regenerating </a:t>
            </a:r>
            <a:r>
              <a:rPr lang="en-US" altLang="zh-CN" sz="1200" dirty="0" err="1" smtClean="0">
                <a:latin typeface="Arial" pitchFamily="34" charset="0"/>
                <a:cs typeface="Arial" pitchFamily="34" charset="0"/>
              </a:rPr>
              <a:t>myofiber</a:t>
            </a:r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 (Day 5).  </a:t>
            </a:r>
            <a:endParaRPr lang="en-US" sz="1200" dirty="0" smtClean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5" name="Connecteur droit avec flèche 25"/>
          <p:cNvCxnSpPr/>
          <p:nvPr/>
        </p:nvCxnSpPr>
        <p:spPr>
          <a:xfrm>
            <a:off x="4071372" y="2023472"/>
            <a:ext cx="72008" cy="72008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Connecteur droit avec flèche 25"/>
          <p:cNvCxnSpPr/>
          <p:nvPr/>
        </p:nvCxnSpPr>
        <p:spPr>
          <a:xfrm>
            <a:off x="4500000" y="2237786"/>
            <a:ext cx="72008" cy="72008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Connecteur droit avec flèche 25"/>
          <p:cNvCxnSpPr/>
          <p:nvPr/>
        </p:nvCxnSpPr>
        <p:spPr>
          <a:xfrm>
            <a:off x="4571438" y="2094910"/>
            <a:ext cx="72008" cy="72008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C7EDCC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1</TotalTime>
  <Words>134</Words>
  <Application>Microsoft Office PowerPoint</Application>
  <PresentationFormat>A4 纸张(210x297 毫米)</PresentationFormat>
  <Paragraphs>7</Paragraphs>
  <Slides>2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3" baseType="lpstr">
      <vt:lpstr>Office 主题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hiro</dc:creator>
  <cp:lastModifiedBy>qiuhuiling </cp:lastModifiedBy>
  <cp:revision>7</cp:revision>
  <dcterms:created xsi:type="dcterms:W3CDTF">2016-09-08T07:27:10Z</dcterms:created>
  <dcterms:modified xsi:type="dcterms:W3CDTF">2017-03-11T09:48:26Z</dcterms:modified>
</cp:coreProperties>
</file>